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99200" cy="10234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4320" rIns="94320" tIns="47160" bIns="4716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021200" y="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4320" rIns="94320" tIns="47160" bIns="4716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11040" y="767880"/>
            <a:ext cx="2878200" cy="3837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94320" rIns="94320" tIns="47160" bIns="4716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4320" rIns="94320" tIns="47160" bIns="4716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4320" rIns="94320" tIns="47160" bIns="47160" anchor="b">
            <a:noAutofit/>
          </a:bodyPr>
          <a:lstStyle>
            <a:lvl1pPr indent="0" algn="r">
              <a:buNone/>
              <a:tabLst>
                <a:tab algn="l" pos="0"/>
                <a:tab algn="l" pos="942840"/>
                <a:tab algn="l" pos="1886040"/>
                <a:tab algn="l" pos="2828880"/>
                <a:tab algn="l" pos="3772080"/>
                <a:tab algn="l" pos="4714920"/>
                <a:tab algn="l" pos="5657760"/>
                <a:tab algn="l" pos="6600960"/>
                <a:tab algn="l" pos="7543800"/>
                <a:tab algn="l" pos="8486640"/>
                <a:tab algn="l" pos="9429840"/>
                <a:tab algn="l" pos="10372680"/>
              </a:tabLst>
              <a:defRPr b="0" lang="en-US" sz="11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42840"/>
                <a:tab algn="l" pos="1886040"/>
                <a:tab algn="l" pos="2828880"/>
                <a:tab algn="l" pos="3772080"/>
                <a:tab algn="l" pos="4714920"/>
                <a:tab algn="l" pos="5657760"/>
                <a:tab algn="l" pos="6600960"/>
                <a:tab algn="l" pos="7543800"/>
                <a:tab algn="l" pos="8486640"/>
                <a:tab algn="l" pos="9429840"/>
                <a:tab algn="l" pos="10372680"/>
              </a:tabLst>
            </a:pPr>
            <a:fld id="{2A0E2B52-531C-4B58-90D7-F75511D59D75}" type="slidenum">
              <a:rPr b="0" lang="en-US" sz="11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sldImg"/>
          </p:nvPr>
        </p:nvSpPr>
        <p:spPr>
          <a:xfrm>
            <a:off x="2111400" y="768240"/>
            <a:ext cx="2878200" cy="3837240"/>
          </a:xfrm>
          <a:prstGeom prst="rect">
            <a:avLst/>
          </a:prstGeom>
          <a:ln w="0">
            <a:noFill/>
          </a:ln>
        </p:spPr>
      </p:sp>
      <p:sp>
        <p:nvSpPr>
          <p:cNvPr id="69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スライド番号プレースホルダ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4320" rIns="94320" tIns="47160" bIns="47160" anchor="b">
            <a:noAutofit/>
          </a:bodyPr>
          <a:p>
            <a:pPr algn="r">
              <a:tabLst>
                <a:tab algn="l" pos="0"/>
                <a:tab algn="l" pos="942840"/>
                <a:tab algn="l" pos="1886040"/>
                <a:tab algn="l" pos="2828880"/>
                <a:tab algn="l" pos="3772080"/>
                <a:tab algn="l" pos="4714920"/>
                <a:tab algn="l" pos="5657760"/>
                <a:tab algn="l" pos="6600960"/>
                <a:tab algn="l" pos="7543800"/>
                <a:tab algn="l" pos="8486640"/>
                <a:tab algn="l" pos="9429840"/>
                <a:tab algn="l" pos="10372680"/>
              </a:tabLst>
            </a:pPr>
            <a:fld id="{9496E9FE-9731-4C98-9A6D-650DA32C9D3A}" type="slidenum">
              <a:rPr b="0" lang="en-US" sz="11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B8C486-F354-4277-AD29-643A8CFAFC8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E1B7D3-37A9-4168-B2C2-21847191501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C0CC62-77B5-4B84-BB05-81E621ADAC5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ABABAD-BD24-4DBB-81C5-A2CA53908FA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8962C2-26FC-4521-B2A7-151DD04679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075909-32FB-4AD0-B1B7-1A62B375768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672757-CB8F-4BD1-A9D2-7AB7E6E086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2D3A1E-68EC-42AB-B8FE-D05F98C643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F6FA93-E6F4-4485-B303-9F99C452B8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62D61E-25C9-4D38-815D-FA688422F8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3D343C-BC1F-43DD-80C9-870FE17DAC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26CB2F-1E67-4422-8940-6826AD9DAB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C139BB4-1774-45D7-A27E-936B076B991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2" descr=""/>
          <p:cNvPicPr/>
          <p:nvPr/>
        </p:nvPicPr>
        <p:blipFill>
          <a:blip r:embed="rId1"/>
          <a:srcRect l="5723" t="0" r="29921" b="11210"/>
          <a:stretch/>
        </p:blipFill>
        <p:spPr>
          <a:xfrm>
            <a:off x="1066680" y="1281240"/>
            <a:ext cx="5105520" cy="3595680"/>
          </a:xfrm>
          <a:prstGeom prst="rect">
            <a:avLst/>
          </a:prstGeom>
          <a:ln w="0">
            <a:noFill/>
          </a:ln>
        </p:spPr>
      </p:pic>
      <p:sp>
        <p:nvSpPr>
          <p:cNvPr id="49" name="Text Box 58"/>
          <p:cNvSpPr/>
          <p:nvPr/>
        </p:nvSpPr>
        <p:spPr>
          <a:xfrm>
            <a:off x="0" y="14400"/>
            <a:ext cx="1828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 fig. 1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79"/>
          <p:cNvSpPr/>
          <p:nvPr/>
        </p:nvSpPr>
        <p:spPr>
          <a:xfrm>
            <a:off x="2314800" y="4935600"/>
            <a:ext cx="26190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600" spc="-1" strike="noStrike">
                <a:solidFill>
                  <a:srgbClr val="000000"/>
                </a:solidFill>
                <a:latin typeface="Arial"/>
              </a:rPr>
              <a:t>Time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fter</a:t>
            </a:r>
            <a:r>
              <a:rPr b="0" lang="ja-JP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PAP injection</a:t>
            </a:r>
            <a:r>
              <a:rPr b="0" lang="ja-JP" sz="1600" spc="-1" strike="noStrike">
                <a:solidFill>
                  <a:srgbClr val="000000"/>
                </a:solidFill>
                <a:latin typeface="Arial"/>
              </a:rPr>
              <a:t> (h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80"/>
          <p:cNvSpPr/>
          <p:nvPr/>
        </p:nvSpPr>
        <p:spPr>
          <a:xfrm rot="16200000">
            <a:off x="209520" y="2846520"/>
            <a:ext cx="150048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rvival rate (%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70"/>
          <p:cNvSpPr/>
          <p:nvPr/>
        </p:nvSpPr>
        <p:spPr>
          <a:xfrm>
            <a:off x="4019400" y="2590920"/>
            <a:ext cx="207648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PAP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73"/>
          <p:cNvSpPr/>
          <p:nvPr/>
        </p:nvSpPr>
        <p:spPr>
          <a:xfrm>
            <a:off x="4038480" y="3013200"/>
            <a:ext cx="2286000" cy="40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PAP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+ ozagrel (200 mg/kg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4" name="グループ化 72"/>
          <p:cNvGrpSpPr/>
          <p:nvPr/>
        </p:nvGrpSpPr>
        <p:grpSpPr>
          <a:xfrm>
            <a:off x="3505320" y="2666880"/>
            <a:ext cx="304560" cy="152640"/>
            <a:chOff x="3505320" y="2666880"/>
            <a:chExt cx="304560" cy="152640"/>
          </a:xfrm>
        </p:grpSpPr>
        <p:sp>
          <p:nvSpPr>
            <p:cNvPr id="55" name="直線コネクタ 19"/>
            <p:cNvSpPr/>
            <p:nvPr/>
          </p:nvSpPr>
          <p:spPr>
            <a:xfrm>
              <a:off x="3505320" y="2743200"/>
              <a:ext cx="30456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円/楕円 20"/>
            <p:cNvSpPr/>
            <p:nvPr/>
          </p:nvSpPr>
          <p:spPr>
            <a:xfrm>
              <a:off x="3581280" y="2666880"/>
              <a:ext cx="152280" cy="152640"/>
            </a:xfrm>
            <a:prstGeom prst="ellipse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7" name="グループ化 24"/>
          <p:cNvGrpSpPr/>
          <p:nvPr/>
        </p:nvGrpSpPr>
        <p:grpSpPr>
          <a:xfrm>
            <a:off x="3505320" y="3200400"/>
            <a:ext cx="304560" cy="152280"/>
            <a:chOff x="3505320" y="3200400"/>
            <a:chExt cx="304560" cy="152280"/>
          </a:xfrm>
        </p:grpSpPr>
        <p:sp>
          <p:nvSpPr>
            <p:cNvPr id="58" name="円/楕円 22"/>
            <p:cNvSpPr/>
            <p:nvPr/>
          </p:nvSpPr>
          <p:spPr>
            <a:xfrm>
              <a:off x="3581280" y="3200400"/>
              <a:ext cx="152280" cy="15228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直線コネクタ 23"/>
            <p:cNvSpPr/>
            <p:nvPr/>
          </p:nvSpPr>
          <p:spPr>
            <a:xfrm>
              <a:off x="3505320" y="3276360"/>
              <a:ext cx="30456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0" name="Rectangle 73"/>
          <p:cNvSpPr/>
          <p:nvPr/>
        </p:nvSpPr>
        <p:spPr>
          <a:xfrm>
            <a:off x="4038480" y="3703680"/>
            <a:ext cx="2286000" cy="40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PAP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+ NAC (600 mg/kg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70"/>
          <p:cNvSpPr/>
          <p:nvPr/>
        </p:nvSpPr>
        <p:spPr>
          <a:xfrm>
            <a:off x="3867120" y="2525760"/>
            <a:ext cx="24768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: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70"/>
          <p:cNvSpPr/>
          <p:nvPr/>
        </p:nvSpPr>
        <p:spPr>
          <a:xfrm>
            <a:off x="3867120" y="3059280"/>
            <a:ext cx="24768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: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70"/>
          <p:cNvSpPr/>
          <p:nvPr/>
        </p:nvSpPr>
        <p:spPr>
          <a:xfrm>
            <a:off x="3867120" y="3668760"/>
            <a:ext cx="24768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: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テキスト ボックス 21"/>
          <p:cNvSpPr/>
          <p:nvPr/>
        </p:nvSpPr>
        <p:spPr>
          <a:xfrm>
            <a:off x="762120" y="5943600"/>
            <a:ext cx="5562360" cy="137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l figur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ig. 1S. Survival rate over a 48-h period in mice after APAP injection. Mice were treated with ozagrel (200 mg/kg), NAC (600 mg/kg) or saline 60 min after the APAP (330 mg/kg) injection. A significant difference (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= 0.001) was observed between the APAP group and the APAP + ozagrel group (n = 12–17)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5" name="グループ化 25"/>
          <p:cNvGrpSpPr/>
          <p:nvPr/>
        </p:nvGrpSpPr>
        <p:grpSpPr>
          <a:xfrm>
            <a:off x="3505320" y="3809880"/>
            <a:ext cx="328320" cy="152640"/>
            <a:chOff x="3505320" y="3809880"/>
            <a:chExt cx="328320" cy="152640"/>
          </a:xfrm>
        </p:grpSpPr>
        <p:sp>
          <p:nvSpPr>
            <p:cNvPr id="66" name="直線コネクタ 28"/>
            <p:cNvSpPr/>
            <p:nvPr/>
          </p:nvSpPr>
          <p:spPr>
            <a:xfrm>
              <a:off x="3505320" y="3886200"/>
              <a:ext cx="32832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二等辺三角形 26"/>
            <p:cNvSpPr/>
            <p:nvPr/>
          </p:nvSpPr>
          <p:spPr>
            <a:xfrm>
              <a:off x="3581280" y="3809880"/>
              <a:ext cx="152280" cy="15264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" bIns="432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26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tomi</dc:creator>
  <dc:description/>
  <dc:language>en-US</dc:language>
  <cp:lastModifiedBy>Yoshiro Tomishima</cp:lastModifiedBy>
  <dcterms:modified xsi:type="dcterms:W3CDTF">2012-08-02T02:07:28Z</dcterms:modified>
  <cp:revision>254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